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" ContentType="image/tiff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67" r:id="rId2"/>
    <p:sldId id="265" r:id="rId3"/>
    <p:sldId id="266" r:id="rId4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4" autoAdjust="0"/>
    <p:restoredTop sz="94660"/>
  </p:normalViewPr>
  <p:slideViewPr>
    <p:cSldViewPr snapToGrid="0">
      <p:cViewPr>
        <p:scale>
          <a:sx n="150" d="100"/>
          <a:sy n="150" d="100"/>
        </p:scale>
        <p:origin x="2184" y="14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B46DA-8175-4E85-8CF9-2207EB919904}" type="datetimeFigureOut">
              <a:rPr lang="en-US" smtClean="0"/>
              <a:t>6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AF753-6F34-4545-A931-B81CBB36EE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03270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B46DA-8175-4E85-8CF9-2207EB919904}" type="datetimeFigureOut">
              <a:rPr lang="en-US" smtClean="0"/>
              <a:t>6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AF753-6F34-4545-A931-B81CBB36EE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67267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B46DA-8175-4E85-8CF9-2207EB919904}" type="datetimeFigureOut">
              <a:rPr lang="en-US" smtClean="0"/>
              <a:t>6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AF753-6F34-4545-A931-B81CBB36EE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61626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B46DA-8175-4E85-8CF9-2207EB919904}" type="datetimeFigureOut">
              <a:rPr lang="en-US" smtClean="0"/>
              <a:t>6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AF753-6F34-4545-A931-B81CBB36EE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50145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B46DA-8175-4E85-8CF9-2207EB919904}" type="datetimeFigureOut">
              <a:rPr lang="en-US" smtClean="0"/>
              <a:t>6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AF753-6F34-4545-A931-B81CBB36EE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7240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B46DA-8175-4E85-8CF9-2207EB919904}" type="datetimeFigureOut">
              <a:rPr lang="en-US" smtClean="0"/>
              <a:t>6/1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AF753-6F34-4545-A931-B81CBB36EE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09835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B46DA-8175-4E85-8CF9-2207EB919904}" type="datetimeFigureOut">
              <a:rPr lang="en-US" smtClean="0"/>
              <a:t>6/19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AF753-6F34-4545-A931-B81CBB36EE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45281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B46DA-8175-4E85-8CF9-2207EB919904}" type="datetimeFigureOut">
              <a:rPr lang="en-US" smtClean="0"/>
              <a:t>6/19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AF753-6F34-4545-A931-B81CBB36EE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38637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B46DA-8175-4E85-8CF9-2207EB919904}" type="datetimeFigureOut">
              <a:rPr lang="en-US" smtClean="0"/>
              <a:t>6/19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AF753-6F34-4545-A931-B81CBB36EE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32355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B46DA-8175-4E85-8CF9-2207EB919904}" type="datetimeFigureOut">
              <a:rPr lang="en-US" smtClean="0"/>
              <a:t>6/1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AF753-6F34-4545-A931-B81CBB36EE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51601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B46DA-8175-4E85-8CF9-2207EB919904}" type="datetimeFigureOut">
              <a:rPr lang="en-US" smtClean="0"/>
              <a:t>6/1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AF753-6F34-4545-A931-B81CBB36EE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42610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5B46DA-8175-4E85-8CF9-2207EB919904}" type="datetimeFigureOut">
              <a:rPr lang="en-US" smtClean="0"/>
              <a:t>6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BAF753-6F34-4545-A931-B81CBB36EE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23447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4" Type="http://schemas.openxmlformats.org/officeDocument/2006/relationships/image" Target="../media/image3.tif"/><Relationship Id="rId5" Type="http://schemas.openxmlformats.org/officeDocument/2006/relationships/image" Target="../media/image4.ti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4" Type="http://schemas.openxmlformats.org/officeDocument/2006/relationships/image" Target="../media/image7.jpe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tiff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image" Target="../media/image15.jpeg"/><Relationship Id="rId20" Type="http://schemas.openxmlformats.org/officeDocument/2006/relationships/image" Target="../media/image26.jpeg"/><Relationship Id="rId21" Type="http://schemas.openxmlformats.org/officeDocument/2006/relationships/image" Target="../media/image27.jpeg"/><Relationship Id="rId22" Type="http://schemas.openxmlformats.org/officeDocument/2006/relationships/image" Target="../media/image28.jpeg"/><Relationship Id="rId23" Type="http://schemas.openxmlformats.org/officeDocument/2006/relationships/image" Target="../media/image29.jpeg"/><Relationship Id="rId24" Type="http://schemas.openxmlformats.org/officeDocument/2006/relationships/image" Target="../media/image30.jpeg"/><Relationship Id="rId25" Type="http://schemas.openxmlformats.org/officeDocument/2006/relationships/image" Target="../media/image31.jpeg"/><Relationship Id="rId26" Type="http://schemas.openxmlformats.org/officeDocument/2006/relationships/image" Target="../media/image32.jpeg"/><Relationship Id="rId27" Type="http://schemas.openxmlformats.org/officeDocument/2006/relationships/image" Target="../media/image33.jpeg"/><Relationship Id="rId10" Type="http://schemas.openxmlformats.org/officeDocument/2006/relationships/image" Target="../media/image16.jpeg"/><Relationship Id="rId11" Type="http://schemas.openxmlformats.org/officeDocument/2006/relationships/image" Target="../media/image17.jpeg"/><Relationship Id="rId12" Type="http://schemas.openxmlformats.org/officeDocument/2006/relationships/image" Target="../media/image18.jpeg"/><Relationship Id="rId13" Type="http://schemas.openxmlformats.org/officeDocument/2006/relationships/image" Target="../media/image19.jpeg"/><Relationship Id="rId14" Type="http://schemas.openxmlformats.org/officeDocument/2006/relationships/image" Target="../media/image20.jpeg"/><Relationship Id="rId15" Type="http://schemas.openxmlformats.org/officeDocument/2006/relationships/image" Target="../media/image21.jpeg"/><Relationship Id="rId16" Type="http://schemas.openxmlformats.org/officeDocument/2006/relationships/image" Target="../media/image22.jpeg"/><Relationship Id="rId17" Type="http://schemas.openxmlformats.org/officeDocument/2006/relationships/image" Target="../media/image23.jpeg"/><Relationship Id="rId18" Type="http://schemas.openxmlformats.org/officeDocument/2006/relationships/image" Target="../media/image24.jpeg"/><Relationship Id="rId19" Type="http://schemas.openxmlformats.org/officeDocument/2006/relationships/image" Target="../media/image25.jpe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.tif"/><Relationship Id="rId3" Type="http://schemas.openxmlformats.org/officeDocument/2006/relationships/image" Target="../media/image9.tif"/><Relationship Id="rId4" Type="http://schemas.openxmlformats.org/officeDocument/2006/relationships/image" Target="../media/image10.tif"/><Relationship Id="rId5" Type="http://schemas.openxmlformats.org/officeDocument/2006/relationships/image" Target="../media/image11.tif"/><Relationship Id="rId6" Type="http://schemas.openxmlformats.org/officeDocument/2006/relationships/image" Target="../media/image12.jpeg"/><Relationship Id="rId7" Type="http://schemas.openxmlformats.org/officeDocument/2006/relationships/image" Target="../media/image13.jpeg"/><Relationship Id="rId8" Type="http://schemas.openxmlformats.org/officeDocument/2006/relationships/image" Target="../media/image1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878463" y="9404973"/>
            <a:ext cx="18707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sp>
        <p:nvSpPr>
          <p:cNvPr id="5" name="Rectangle 4"/>
          <p:cNvSpPr/>
          <p:nvPr/>
        </p:nvSpPr>
        <p:spPr>
          <a:xfrm>
            <a:off x="218533" y="5978597"/>
            <a:ext cx="6530676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Supplementary Fig. 1. Comparison of SETMAR expression in the SM and SMF cell lines. </a:t>
            </a:r>
            <a:r>
              <a:rPr lang="en-US" sz="1400" dirty="0"/>
              <a:t>Western blot for SETMAR and the Flag-tagged SETMAR in the U2OS, SM2, SM3, SETF2 and SMF3 cell lines. The western blot was performed with anti-Hsmar1 transposase, anti-Flag and anti-β-tubulin antibodies.</a:t>
            </a:r>
          </a:p>
        </p:txBody>
      </p:sp>
      <p:pic>
        <p:nvPicPr>
          <p:cNvPr id="7" name="Picture 6" descr="WB_Tubulin.ti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" r="22811" b="-414"/>
          <a:stretch/>
        </p:blipFill>
        <p:spPr>
          <a:xfrm>
            <a:off x="449580" y="5226150"/>
            <a:ext cx="3539490" cy="351689"/>
          </a:xfrm>
          <a:prstGeom prst="rect">
            <a:avLst/>
          </a:prstGeom>
        </p:spPr>
      </p:pic>
      <p:pic>
        <p:nvPicPr>
          <p:cNvPr id="8" name="Picture 7" descr="WB_SETMAR.tif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3164" b="-616"/>
          <a:stretch/>
        </p:blipFill>
        <p:spPr>
          <a:xfrm>
            <a:off x="449580" y="3902965"/>
            <a:ext cx="3523328" cy="352399"/>
          </a:xfrm>
          <a:prstGeom prst="rect">
            <a:avLst/>
          </a:prstGeom>
        </p:spPr>
      </p:pic>
      <p:pic>
        <p:nvPicPr>
          <p:cNvPr id="9" name="Picture 8" descr="WB_SETMAR_FLAG.tif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" r="22811" b="-11896"/>
          <a:stretch/>
        </p:blipFill>
        <p:spPr>
          <a:xfrm>
            <a:off x="449580" y="4328684"/>
            <a:ext cx="3539490" cy="391906"/>
          </a:xfrm>
          <a:prstGeom prst="rect">
            <a:avLst/>
          </a:prstGeom>
        </p:spPr>
      </p:pic>
      <p:pic>
        <p:nvPicPr>
          <p:cNvPr id="10" name="Picture 9" descr="WB_SET_FLAG.tif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2811" b="-299"/>
          <a:stretch/>
        </p:blipFill>
        <p:spPr>
          <a:xfrm>
            <a:off x="449580" y="4765912"/>
            <a:ext cx="3539490" cy="351290"/>
          </a:xfrm>
          <a:prstGeom prst="rect">
            <a:avLst/>
          </a:prstGeom>
        </p:spPr>
      </p:pic>
      <p:sp>
        <p:nvSpPr>
          <p:cNvPr id="11" name="Rectangle 10"/>
          <p:cNvSpPr/>
          <p:nvPr/>
        </p:nvSpPr>
        <p:spPr>
          <a:xfrm>
            <a:off x="449580" y="3891459"/>
            <a:ext cx="3539490" cy="363905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/>
          </a:p>
        </p:txBody>
      </p:sp>
      <p:sp>
        <p:nvSpPr>
          <p:cNvPr id="12" name="Rectangle 11"/>
          <p:cNvSpPr/>
          <p:nvPr/>
        </p:nvSpPr>
        <p:spPr>
          <a:xfrm>
            <a:off x="449580" y="4328686"/>
            <a:ext cx="3539490" cy="357597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/>
          </a:p>
        </p:txBody>
      </p:sp>
      <p:sp>
        <p:nvSpPr>
          <p:cNvPr id="13" name="Rectangle 12"/>
          <p:cNvSpPr/>
          <p:nvPr/>
        </p:nvSpPr>
        <p:spPr>
          <a:xfrm>
            <a:off x="449580" y="4765912"/>
            <a:ext cx="3539490" cy="366149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/>
          </a:p>
        </p:txBody>
      </p:sp>
      <p:sp>
        <p:nvSpPr>
          <p:cNvPr id="14" name="Rectangle 13"/>
          <p:cNvSpPr/>
          <p:nvPr/>
        </p:nvSpPr>
        <p:spPr>
          <a:xfrm>
            <a:off x="449580" y="5209582"/>
            <a:ext cx="3539490" cy="368258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/>
          </a:p>
        </p:txBody>
      </p:sp>
      <p:sp>
        <p:nvSpPr>
          <p:cNvPr id="15" name="TextBox 14"/>
          <p:cNvSpPr txBox="1"/>
          <p:nvPr/>
        </p:nvSpPr>
        <p:spPr>
          <a:xfrm>
            <a:off x="3986493" y="3933550"/>
            <a:ext cx="2380780" cy="253916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1050" dirty="0" smtClean="0">
                <a:latin typeface="Helvetica"/>
              </a:rPr>
              <a:t>SETMAR (anti-Hsmar1 transposase)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3986493" y="4361811"/>
            <a:ext cx="1282737" cy="306090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1050" dirty="0" smtClean="0">
                <a:latin typeface="Helvetica"/>
              </a:rPr>
              <a:t>SETMAR-FLAG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3986493" y="5233126"/>
            <a:ext cx="792060" cy="306090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1050" dirty="0" smtClean="0">
                <a:latin typeface="Helvetica"/>
              </a:rPr>
              <a:t>β-tubulin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3986493" y="4798928"/>
            <a:ext cx="935909" cy="306090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1050" dirty="0" smtClean="0">
                <a:latin typeface="Helvetica"/>
              </a:rPr>
              <a:t>SET-FLAG        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465631" y="3297766"/>
            <a:ext cx="551754" cy="253916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1050" dirty="0" smtClean="0">
                <a:latin typeface="Helvetica"/>
              </a:rPr>
              <a:t>U2OS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2417409" y="3297766"/>
            <a:ext cx="678391" cy="253916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1050" dirty="0" smtClean="0">
                <a:latin typeface="Helvetica"/>
              </a:rPr>
              <a:t>U2OS-F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1622080" y="3593206"/>
            <a:ext cx="284128" cy="306090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1050" dirty="0" smtClean="0">
                <a:latin typeface="Helvetica"/>
              </a:rPr>
              <a:t>2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2099507" y="3593206"/>
            <a:ext cx="284128" cy="306090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1050" dirty="0" smtClean="0">
                <a:latin typeface="Helvetica"/>
              </a:rPr>
              <a:t>3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1138506" y="3593206"/>
            <a:ext cx="284128" cy="306090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1050" dirty="0" smtClean="0">
                <a:latin typeface="Helvetica"/>
              </a:rPr>
              <a:t>1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2989547" y="3297766"/>
            <a:ext cx="603050" cy="253916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1050" dirty="0" smtClean="0">
                <a:latin typeface="Helvetica"/>
              </a:rPr>
              <a:t>SETF2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547853" y="3297766"/>
            <a:ext cx="427902" cy="306090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1050" dirty="0" smtClean="0">
                <a:latin typeface="Helvetica"/>
              </a:rPr>
              <a:t>SM</a:t>
            </a:r>
          </a:p>
        </p:txBody>
      </p:sp>
      <p:cxnSp>
        <p:nvCxnSpPr>
          <p:cNvPr id="26" name="Straight Connector 25"/>
          <p:cNvCxnSpPr/>
          <p:nvPr/>
        </p:nvCxnSpPr>
        <p:spPr>
          <a:xfrm>
            <a:off x="1226390" y="3584995"/>
            <a:ext cx="1154883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3482451" y="3297766"/>
            <a:ext cx="567138" cy="253916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r>
              <a:rPr lang="en-US" sz="1050" dirty="0" smtClean="0">
                <a:latin typeface="Helvetica"/>
              </a:rPr>
              <a:t>SMF3</a:t>
            </a:r>
          </a:p>
        </p:txBody>
      </p:sp>
    </p:spTree>
    <p:extLst>
      <p:ext uri="{BB962C8B-B14F-4D97-AF65-F5344CB8AC3E}">
        <p14:creationId xmlns:p14="http://schemas.microsoft.com/office/powerpoint/2010/main" val="31738572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7413"/>
          <a:stretch/>
        </p:blipFill>
        <p:spPr>
          <a:xfrm>
            <a:off x="1410052" y="2493186"/>
            <a:ext cx="1517424" cy="2770632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 rot="16200000">
            <a:off x="-45328" y="3790150"/>
            <a:ext cx="26337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umber of G418</a:t>
            </a:r>
            <a:r>
              <a:rPr lang="en-US" sz="1200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olonies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639302" y="5263818"/>
            <a:ext cx="7612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ircular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265101" y="5263818"/>
            <a:ext cx="7612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near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492534" y="5528081"/>
            <a:ext cx="16681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2OS-F parental line</a:t>
            </a:r>
            <a:endParaRPr lang="en-U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Straight Connector 8"/>
          <p:cNvCxnSpPr/>
          <p:nvPr/>
        </p:nvCxnSpPr>
        <p:spPr>
          <a:xfrm flipV="1">
            <a:off x="2542382" y="3150683"/>
            <a:ext cx="0" cy="114648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2090093" y="3150683"/>
            <a:ext cx="4572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2311721" y="4270133"/>
            <a:ext cx="4664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Straight Connector 12"/>
          <p:cNvCxnSpPr/>
          <p:nvPr/>
        </p:nvCxnSpPr>
        <p:spPr>
          <a:xfrm flipH="1" flipV="1">
            <a:off x="2542382" y="4420765"/>
            <a:ext cx="0" cy="13716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6" name="Picture 15" descr="TOcir_F5.jpg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160690" y="2950662"/>
            <a:ext cx="909613" cy="914801"/>
          </a:xfrm>
          <a:prstGeom prst="rect">
            <a:avLst/>
          </a:prstGeom>
        </p:spPr>
      </p:pic>
      <p:pic>
        <p:nvPicPr>
          <p:cNvPr id="17" name="Picture 16" descr="TOlin_F5.jpg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337192" y="2949935"/>
            <a:ext cx="911208" cy="915528"/>
          </a:xfrm>
          <a:prstGeom prst="rect">
            <a:avLst/>
          </a:prstGeom>
        </p:spPr>
      </p:pic>
      <p:sp>
        <p:nvSpPr>
          <p:cNvPr id="18" name="TextBox 17"/>
          <p:cNvSpPr txBox="1"/>
          <p:nvPr/>
        </p:nvSpPr>
        <p:spPr>
          <a:xfrm>
            <a:off x="3277837" y="2709763"/>
            <a:ext cx="651140" cy="253916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1050" dirty="0">
                <a:solidFill>
                  <a:prstClr val="black"/>
                </a:solidFill>
                <a:latin typeface="Helvetica"/>
              </a:rPr>
              <a:t>C</a:t>
            </a:r>
            <a:r>
              <a:rPr lang="en-US" sz="1050" dirty="0" smtClean="0">
                <a:solidFill>
                  <a:prstClr val="black"/>
                </a:solidFill>
                <a:latin typeface="Helvetica"/>
              </a:rPr>
              <a:t>ircular</a:t>
            </a:r>
            <a:endParaRPr lang="en-US" sz="1050" dirty="0">
              <a:solidFill>
                <a:prstClr val="black"/>
              </a:solidFill>
              <a:latin typeface="Helvetica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4505697" y="2709763"/>
            <a:ext cx="561372" cy="253916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1050" dirty="0">
                <a:solidFill>
                  <a:prstClr val="black"/>
                </a:solidFill>
                <a:latin typeface="Helvetica"/>
              </a:rPr>
              <a:t>L</a:t>
            </a:r>
            <a:r>
              <a:rPr lang="en-US" sz="1050" dirty="0" smtClean="0">
                <a:solidFill>
                  <a:prstClr val="black"/>
                </a:solidFill>
                <a:latin typeface="Helvetica"/>
              </a:rPr>
              <a:t>inear</a:t>
            </a:r>
            <a:endParaRPr lang="en-US" sz="1050" dirty="0">
              <a:solidFill>
                <a:prstClr val="black"/>
              </a:solidFill>
              <a:latin typeface="Helvetica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357540" y="3865463"/>
            <a:ext cx="548285" cy="246221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prstClr val="black"/>
                </a:solidFill>
                <a:latin typeface="Helvetica"/>
              </a:rPr>
              <a:t>0.93%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4553091" y="3865463"/>
            <a:ext cx="548285" cy="246221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prstClr val="black"/>
                </a:solidFill>
                <a:latin typeface="Helvetica"/>
              </a:rPr>
              <a:t>0.27%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4878463" y="9404973"/>
            <a:ext cx="18707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2</a:t>
            </a:r>
            <a:endParaRPr lang="en-U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2832375" y="2481756"/>
            <a:ext cx="353715" cy="327378"/>
          </a:xfrm>
          <a:prstGeom prst="rect">
            <a:avLst/>
          </a:prstGeom>
          <a:noFill/>
          <a:effectLst/>
        </p:spPr>
        <p:txBody>
          <a:bodyPr wrap="none" lIns="110853" tIns="55426" rIns="110853" bIns="55426" rtlCol="0">
            <a:spAutoFit/>
          </a:bodyPr>
          <a:lstStyle/>
          <a:p>
            <a:r>
              <a:rPr lang="en-US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903585" y="2481756"/>
            <a:ext cx="353715" cy="327378"/>
          </a:xfrm>
          <a:prstGeom prst="rect">
            <a:avLst/>
          </a:prstGeom>
          <a:noFill/>
          <a:effectLst/>
        </p:spPr>
        <p:txBody>
          <a:bodyPr wrap="none" lIns="110853" tIns="55426" rIns="110853" bIns="55426" rtlCol="0">
            <a:spAutoFit/>
          </a:bodyPr>
          <a:lstStyle/>
          <a:p>
            <a:r>
              <a:rPr lang="en-US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" name="Rectangle 1"/>
          <p:cNvSpPr/>
          <p:nvPr/>
        </p:nvSpPr>
        <p:spPr>
          <a:xfrm>
            <a:off x="218533" y="5978597"/>
            <a:ext cx="6530676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b="1" dirty="0"/>
              <a:t>Supplementary Fig. 2. A circularized plasmid is more efficiently integrated than a linearized plasmid. A</a:t>
            </a:r>
            <a:r>
              <a:rPr lang="en-GB" sz="1400" dirty="0"/>
              <a:t>, Comparison of the integration efficiency in the parental cell line, U2OS-F, of a circularized or linearized pRC1714 plasmid, which encodes a neomycin resistance gene. Average ± S.E.M of three biological replicates. Statistical test: student t-test, ** p-value &lt; 0.01. </a:t>
            </a:r>
            <a:r>
              <a:rPr lang="en-GB" sz="1400" b="1" dirty="0"/>
              <a:t>B</a:t>
            </a:r>
            <a:r>
              <a:rPr lang="en-GB" sz="1400" dirty="0"/>
              <a:t>, Representative pictures of integration plates. The integration rate of each cell line is indicated below each picture.</a:t>
            </a:r>
            <a:endParaRPr lang="en-US" sz="1400" dirty="0"/>
          </a:p>
        </p:txBody>
      </p:sp>
      <p:sp>
        <p:nvSpPr>
          <p:cNvPr id="25" name="TextBox 24"/>
          <p:cNvSpPr txBox="1"/>
          <p:nvPr/>
        </p:nvSpPr>
        <p:spPr>
          <a:xfrm>
            <a:off x="3466093" y="2510839"/>
            <a:ext cx="1452642" cy="253916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1050" dirty="0" smtClean="0">
                <a:solidFill>
                  <a:prstClr val="black"/>
                </a:solidFill>
                <a:latin typeface="Helvetica"/>
              </a:rPr>
              <a:t>U2OS-F parental line</a:t>
            </a:r>
            <a:endParaRPr lang="en-US" sz="1050" dirty="0">
              <a:solidFill>
                <a:prstClr val="black"/>
              </a:solidFill>
              <a:latin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35734367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TextBox 89"/>
          <p:cNvSpPr txBox="1"/>
          <p:nvPr/>
        </p:nvSpPr>
        <p:spPr>
          <a:xfrm>
            <a:off x="4878463" y="9404973"/>
            <a:ext cx="18707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217851" y="6624226"/>
            <a:ext cx="6420751" cy="16004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b="1" dirty="0"/>
              <a:t>Supplementary Fig. 3. Representative FACS profiles of each cell lines. </a:t>
            </a:r>
            <a:r>
              <a:rPr lang="en-GB" sz="1400" dirty="0"/>
              <a:t>FACS profiles of a </a:t>
            </a:r>
            <a:r>
              <a:rPr lang="en-GB" sz="1400" dirty="0" err="1"/>
              <a:t>pRFP</a:t>
            </a:r>
            <a:r>
              <a:rPr lang="en-GB" sz="1400" dirty="0"/>
              <a:t> plasmid used together with the pEGFP-Pem1-Ad2 reporter substrate are shown for each cell line. The profiles were generated using </a:t>
            </a:r>
            <a:r>
              <a:rPr lang="en-GB" sz="1400" dirty="0" err="1"/>
              <a:t>HindIII</a:t>
            </a:r>
            <a:r>
              <a:rPr lang="en-GB" sz="1400" dirty="0"/>
              <a:t>- (H3) and I-</a:t>
            </a:r>
            <a:r>
              <a:rPr lang="en-GB" sz="1400" dirty="0" err="1"/>
              <a:t>SceI</a:t>
            </a:r>
            <a:r>
              <a:rPr lang="en-GB" sz="1400" dirty="0"/>
              <a:t>- (SI) linearized plasmids. The proportion of repaired substrate is indicated in the lower right-hand corner of each profile. The percent is calculated from the number of cells that were doubly EGFP (horizontal) and RFP (vertical) positive versus the number of RFP positive.</a:t>
            </a:r>
            <a:endParaRPr lang="en-US" sz="1400" dirty="0"/>
          </a:p>
        </p:txBody>
      </p:sp>
      <p:grpSp>
        <p:nvGrpSpPr>
          <p:cNvPr id="46" name="Group 45"/>
          <p:cNvGrpSpPr/>
          <p:nvPr/>
        </p:nvGrpSpPr>
        <p:grpSpPr>
          <a:xfrm>
            <a:off x="35375" y="1498060"/>
            <a:ext cx="6569778" cy="4980767"/>
            <a:chOff x="35375" y="1498060"/>
            <a:chExt cx="6569778" cy="4980767"/>
          </a:xfrm>
        </p:grpSpPr>
        <p:pic>
          <p:nvPicPr>
            <p:cNvPr id="11" name="Picture 10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972" b="4622"/>
            <a:stretch/>
          </p:blipFill>
          <p:spPr>
            <a:xfrm>
              <a:off x="2681971" y="3884071"/>
              <a:ext cx="795519" cy="822960"/>
            </a:xfrm>
            <a:prstGeom prst="rect">
              <a:avLst/>
            </a:prstGeom>
          </p:spPr>
        </p:pic>
        <p:pic>
          <p:nvPicPr>
            <p:cNvPr id="44" name="Picture 43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71" b="4622"/>
            <a:stretch/>
          </p:blipFill>
          <p:spPr>
            <a:xfrm>
              <a:off x="5743215" y="3913363"/>
              <a:ext cx="813560" cy="822960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411" b="4578"/>
            <a:stretch/>
          </p:blipFill>
          <p:spPr>
            <a:xfrm>
              <a:off x="1893594" y="2684125"/>
              <a:ext cx="816562" cy="822960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769" b="5042"/>
            <a:stretch/>
          </p:blipFill>
          <p:spPr>
            <a:xfrm>
              <a:off x="4962330" y="1590190"/>
              <a:ext cx="792857" cy="822960"/>
            </a:xfrm>
            <a:prstGeom prst="rect">
              <a:avLst/>
            </a:prstGeom>
          </p:spPr>
        </p:pic>
        <p:pic>
          <p:nvPicPr>
            <p:cNvPr id="14" name="Picture 13" descr="TOF1_SI.jpg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5731" y="3863494"/>
              <a:ext cx="766440" cy="884110"/>
            </a:xfrm>
            <a:prstGeom prst="rect">
              <a:avLst/>
            </a:prstGeom>
          </p:spPr>
        </p:pic>
        <p:pic>
          <p:nvPicPr>
            <p:cNvPr id="15" name="Picture 14" descr="SETF2_SI.jpg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49346" y="3863492"/>
              <a:ext cx="767906" cy="885801"/>
            </a:xfrm>
            <a:prstGeom prst="rect">
              <a:avLst/>
            </a:prstGeom>
          </p:spPr>
        </p:pic>
        <p:pic>
          <p:nvPicPr>
            <p:cNvPr id="16" name="Picture 15" descr="TO3_H3.jpg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2112" y="1606134"/>
              <a:ext cx="767913" cy="808852"/>
            </a:xfrm>
            <a:prstGeom prst="rect">
              <a:avLst/>
            </a:prstGeom>
          </p:spPr>
        </p:pic>
        <p:pic>
          <p:nvPicPr>
            <p:cNvPr id="17" name="Picture 16" descr="SM6_H3.jpg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99997" y="1609258"/>
              <a:ext cx="765326" cy="806127"/>
            </a:xfrm>
            <a:prstGeom prst="rect">
              <a:avLst/>
            </a:prstGeom>
          </p:spPr>
        </p:pic>
        <p:pic>
          <p:nvPicPr>
            <p:cNvPr id="18" name="Picture 17" descr="SM3_H3.jpg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49320" y="1603009"/>
              <a:ext cx="767915" cy="808853"/>
            </a:xfrm>
            <a:prstGeom prst="rect">
              <a:avLst/>
            </a:prstGeom>
          </p:spPr>
        </p:pic>
        <p:pic>
          <p:nvPicPr>
            <p:cNvPr id="19" name="Picture 18" descr="TOF1_H3.jpg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15804" y="1609259"/>
              <a:ext cx="767915" cy="808853"/>
            </a:xfrm>
            <a:prstGeom prst="rect">
              <a:avLst/>
            </a:prstGeom>
          </p:spPr>
        </p:pic>
        <p:pic>
          <p:nvPicPr>
            <p:cNvPr id="20" name="Picture 19" descr="SETF2_H3.jpg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82289" y="1603009"/>
              <a:ext cx="773635" cy="814878"/>
            </a:xfrm>
            <a:prstGeom prst="rect">
              <a:avLst/>
            </a:prstGeom>
          </p:spPr>
        </p:pic>
        <p:pic>
          <p:nvPicPr>
            <p:cNvPr id="21" name="Picture 20" descr="SETF1_H3.jpg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55925" y="1609258"/>
              <a:ext cx="765326" cy="806127"/>
            </a:xfrm>
            <a:prstGeom prst="rect">
              <a:avLst/>
            </a:prstGeom>
          </p:spPr>
        </p:pic>
        <p:pic>
          <p:nvPicPr>
            <p:cNvPr id="22" name="Picture 21" descr="MARF3_H3.jpg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27658" y="1611325"/>
              <a:ext cx="765325" cy="806126"/>
            </a:xfrm>
            <a:prstGeom prst="rect">
              <a:avLst/>
            </a:prstGeom>
          </p:spPr>
        </p:pic>
        <p:pic>
          <p:nvPicPr>
            <p:cNvPr id="23" name="Picture 22" descr="SMF3_H3.jpg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1854" y="2692498"/>
              <a:ext cx="798981" cy="886968"/>
            </a:xfrm>
            <a:prstGeom prst="rect">
              <a:avLst/>
            </a:prstGeom>
          </p:spPr>
        </p:pic>
        <p:pic>
          <p:nvPicPr>
            <p:cNvPr id="24" name="Picture 23" descr="SMF7_H3.jpg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40202" y="2690834"/>
              <a:ext cx="736896" cy="885800"/>
            </a:xfrm>
            <a:prstGeom prst="rect">
              <a:avLst/>
            </a:prstGeom>
          </p:spPr>
        </p:pic>
        <p:pic>
          <p:nvPicPr>
            <p:cNvPr id="25" name="Picture 24" descr="RA104_H3.jpg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65163" y="2690129"/>
              <a:ext cx="767907" cy="885801"/>
            </a:xfrm>
            <a:prstGeom prst="rect">
              <a:avLst/>
            </a:prstGeom>
          </p:spPr>
        </p:pic>
        <p:pic>
          <p:nvPicPr>
            <p:cNvPr id="26" name="Picture 25" descr="DA483_H3.jpg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28129" y="2690129"/>
              <a:ext cx="766441" cy="884110"/>
            </a:xfrm>
            <a:prstGeom prst="rect">
              <a:avLst/>
            </a:prstGeom>
          </p:spPr>
        </p:pic>
        <p:pic>
          <p:nvPicPr>
            <p:cNvPr id="27" name="Picture 26" descr="TO3_SI.jpg"/>
            <p:cNvPicPr>
              <a:picLocks noChangeAspect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78929" y="2690129"/>
              <a:ext cx="766441" cy="884111"/>
            </a:xfrm>
            <a:prstGeom prst="rect">
              <a:avLst/>
            </a:prstGeom>
          </p:spPr>
        </p:pic>
        <p:pic>
          <p:nvPicPr>
            <p:cNvPr id="28" name="Picture 27" descr="SM6_SI.jpg"/>
            <p:cNvPicPr>
              <a:picLocks noChangeAspect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43633" y="2690131"/>
              <a:ext cx="766441" cy="884110"/>
            </a:xfrm>
            <a:prstGeom prst="rect">
              <a:avLst/>
            </a:prstGeom>
          </p:spPr>
        </p:pic>
        <p:pic>
          <p:nvPicPr>
            <p:cNvPr id="29" name="Picture 28" descr="TOF1_SI.jpg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22241" y="2690129"/>
              <a:ext cx="767907" cy="885801"/>
            </a:xfrm>
            <a:prstGeom prst="rect">
              <a:avLst/>
            </a:prstGeom>
          </p:spPr>
        </p:pic>
        <p:pic>
          <p:nvPicPr>
            <p:cNvPr id="30" name="Picture 29" descr="SETF1_SI.jpg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5339" y="3885514"/>
              <a:ext cx="764702" cy="882105"/>
            </a:xfrm>
            <a:prstGeom prst="rect">
              <a:avLst/>
            </a:prstGeom>
          </p:spPr>
        </p:pic>
        <p:pic>
          <p:nvPicPr>
            <p:cNvPr id="31" name="Picture 30" descr="MARF3_SI.jpg"/>
            <p:cNvPicPr>
              <a:picLocks noChangeAspect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79906" y="3905099"/>
              <a:ext cx="767907" cy="885801"/>
            </a:xfrm>
            <a:prstGeom prst="rect">
              <a:avLst/>
            </a:prstGeom>
          </p:spPr>
        </p:pic>
        <p:pic>
          <p:nvPicPr>
            <p:cNvPr id="32" name="Picture 31" descr="SMF3_SI.jpg"/>
            <p:cNvPicPr>
              <a:picLocks noChangeAspect="1"/>
            </p:cNvPicPr>
            <p:nvPr/>
          </p:nvPicPr>
          <p:blipFill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15065" y="3905099"/>
              <a:ext cx="767907" cy="885801"/>
            </a:xfrm>
            <a:prstGeom prst="rect">
              <a:avLst/>
            </a:prstGeom>
          </p:spPr>
        </p:pic>
        <p:pic>
          <p:nvPicPr>
            <p:cNvPr id="33" name="Picture 32" descr="SMF7_SI.jpg"/>
            <p:cNvPicPr>
              <a:picLocks noChangeAspect="1"/>
            </p:cNvPicPr>
            <p:nvPr/>
          </p:nvPicPr>
          <p:blipFill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65864" y="3905098"/>
              <a:ext cx="767906" cy="885801"/>
            </a:xfrm>
            <a:prstGeom prst="rect">
              <a:avLst/>
            </a:prstGeom>
          </p:spPr>
        </p:pic>
        <p:pic>
          <p:nvPicPr>
            <p:cNvPr id="34" name="Picture 33" descr="RA104_SI.jpg"/>
            <p:cNvPicPr>
              <a:picLocks noChangeAspect="1"/>
            </p:cNvPicPr>
            <p:nvPr/>
          </p:nvPicPr>
          <p:blipFill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5700" y="4961345"/>
              <a:ext cx="780344" cy="881642"/>
            </a:xfrm>
            <a:prstGeom prst="rect">
              <a:avLst/>
            </a:prstGeom>
          </p:spPr>
        </p:pic>
        <p:pic>
          <p:nvPicPr>
            <p:cNvPr id="35" name="Picture 34" descr="DA483_SI.jpg"/>
            <p:cNvPicPr>
              <a:picLocks noChangeAspect="1"/>
            </p:cNvPicPr>
            <p:nvPr/>
          </p:nvPicPr>
          <p:blipFill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23450" y="4961345"/>
              <a:ext cx="780345" cy="881642"/>
            </a:xfrm>
            <a:prstGeom prst="rect">
              <a:avLst/>
            </a:prstGeom>
          </p:spPr>
        </p:pic>
        <p:cxnSp>
          <p:nvCxnSpPr>
            <p:cNvPr id="36" name="Straight Arrow Connector 35"/>
            <p:cNvCxnSpPr/>
            <p:nvPr/>
          </p:nvCxnSpPr>
          <p:spPr>
            <a:xfrm>
              <a:off x="459438" y="6232606"/>
              <a:ext cx="5985543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Arrow Connector 36"/>
            <p:cNvCxnSpPr/>
            <p:nvPr/>
          </p:nvCxnSpPr>
          <p:spPr>
            <a:xfrm flipV="1">
              <a:off x="345731" y="1498060"/>
              <a:ext cx="0" cy="4734547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/>
            <p:cNvSpPr txBox="1"/>
            <p:nvPr/>
          </p:nvSpPr>
          <p:spPr>
            <a:xfrm>
              <a:off x="491304" y="2367330"/>
              <a:ext cx="731290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2OS </a:t>
              </a:r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3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1224141" y="2360036"/>
              <a:ext cx="184731" cy="40011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endPara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1224141" y="2377058"/>
              <a:ext cx="646330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M2 H3</a:t>
              </a: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2002749" y="2377058"/>
              <a:ext cx="646330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M3 H3</a:t>
              </a: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2665648" y="2377058"/>
              <a:ext cx="853119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2OS-F </a:t>
              </a:r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3</a:t>
              </a: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3476541" y="2377058"/>
              <a:ext cx="780983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TF1 H3</a:t>
              </a: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4255148" y="2377058"/>
              <a:ext cx="780983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TF2 H3</a:t>
              </a: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5851677" y="2377058"/>
              <a:ext cx="747320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RF H3</a:t>
              </a: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453626" y="3478943"/>
              <a:ext cx="724878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MF2 H3</a:t>
              </a: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1151454" y="3478943"/>
              <a:ext cx="724878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MF3 H3</a:t>
              </a: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2686595" y="3478943"/>
              <a:ext cx="888384" cy="40011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MF-R432A</a:t>
              </a:r>
            </a:p>
            <a:p>
              <a:pPr algn="ctr"/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3</a:t>
              </a: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3469902" y="3478943"/>
              <a:ext cx="880369" cy="40011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MF D483A</a:t>
              </a:r>
            </a:p>
            <a:p>
              <a:pPr algn="ctr"/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3</a:t>
              </a: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5057976" y="4730130"/>
              <a:ext cx="681597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MF3 SI</a:t>
              </a: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4326515" y="3478943"/>
              <a:ext cx="688009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2OS </a:t>
              </a:r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5126118" y="3478943"/>
              <a:ext cx="603051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M2 SI</a:t>
              </a: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5890822" y="3478943"/>
              <a:ext cx="603051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M3 SI</a:t>
              </a: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397156" y="4730130"/>
              <a:ext cx="809837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2OS-F </a:t>
              </a:r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1262312" y="4730130"/>
              <a:ext cx="737702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TF1 SI</a:t>
              </a: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1974856" y="4730130"/>
              <a:ext cx="737702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TF2 SI</a:t>
              </a: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3570280" y="4730130"/>
              <a:ext cx="704039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RF SI</a:t>
              </a: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4314128" y="4730130"/>
              <a:ext cx="724878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MF2 H3</a:t>
              </a: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361854" y="5793083"/>
              <a:ext cx="888384" cy="40011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MF-R432A</a:t>
              </a:r>
            </a:p>
            <a:p>
              <a:pPr algn="ctr"/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1206933" y="5793083"/>
              <a:ext cx="880369" cy="40011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MF D483A</a:t>
              </a:r>
            </a:p>
            <a:p>
              <a:pPr algn="ctr"/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35375" y="3416267"/>
              <a:ext cx="338554" cy="348813"/>
            </a:xfrm>
            <a:prstGeom prst="rect">
              <a:avLst/>
            </a:prstGeom>
            <a:noFill/>
            <a:effectLst/>
          </p:spPr>
          <p:txBody>
            <a:bodyPr vert="vert270" wrap="non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FP</a:t>
              </a: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2809163" y="6232606"/>
              <a:ext cx="532518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GFP</a:t>
              </a: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631429" y="2090043"/>
              <a:ext cx="545341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9.1%</a:t>
              </a: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1356227" y="2098564"/>
              <a:ext cx="545341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1.3%</a:t>
              </a: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2116551" y="2080721"/>
              <a:ext cx="545341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9.2%</a:t>
              </a: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4437885" y="3231431"/>
              <a:ext cx="545341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0.4%</a:t>
              </a: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5200783" y="3231431"/>
              <a:ext cx="545341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2.2%</a:t>
              </a: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5974244" y="3231431"/>
              <a:ext cx="545341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9.2%</a:t>
              </a: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2900305" y="2090246"/>
              <a:ext cx="545341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9.0%</a:t>
              </a: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4427138" y="2090246"/>
              <a:ext cx="545341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1.4%</a:t>
              </a: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5986336" y="2101838"/>
              <a:ext cx="545341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0.5%</a:t>
              </a: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650828" y="3232535"/>
              <a:ext cx="545341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0.5%</a:t>
              </a: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2938858" y="3231431"/>
              <a:ext cx="545341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1.9%</a:t>
              </a: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3680133" y="3231431"/>
              <a:ext cx="545341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6.1%</a:t>
              </a: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614210" y="4404794"/>
              <a:ext cx="545341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2.1%</a:t>
              </a: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2174656" y="4433926"/>
              <a:ext cx="545341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0.9%</a:t>
              </a: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3751796" y="4453511"/>
              <a:ext cx="545341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3.2%</a:t>
              </a: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4479166" y="4453511"/>
              <a:ext cx="545341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.1%</a:t>
              </a: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653229" y="5515123"/>
              <a:ext cx="545341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.7%</a:t>
              </a: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1408407" y="5505598"/>
              <a:ext cx="545341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0.1%</a:t>
              </a: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3665008" y="2090246"/>
              <a:ext cx="545341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5.5%</a:t>
              </a: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1369331" y="3231431"/>
              <a:ext cx="545341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7.7%</a:t>
              </a: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1408301" y="4404794"/>
              <a:ext cx="545341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4.7%</a:t>
              </a: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5239492" y="4463036"/>
              <a:ext cx="545341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4.3%</a:t>
              </a: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4923735" y="2377058"/>
              <a:ext cx="971741" cy="400110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TF N210A </a:t>
              </a:r>
            </a:p>
            <a:p>
              <a:pPr algn="ctr"/>
              <a:r>
                <a:rPr lang="en-US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3</a:t>
              </a:r>
              <a:endPara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1869092" y="3478943"/>
              <a:ext cx="915636" cy="400110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MF N210A </a:t>
              </a:r>
            </a:p>
            <a:p>
              <a:pPr algn="ctr"/>
              <a:r>
                <a:rPr lang="en-US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3</a:t>
              </a:r>
              <a:endPara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2621568" y="4730130"/>
              <a:ext cx="971741" cy="400110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TF N210A </a:t>
              </a:r>
            </a:p>
            <a:p>
              <a:pPr algn="ctr"/>
              <a:r>
                <a:rPr lang="en-US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endPara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5689517" y="4730130"/>
              <a:ext cx="915636" cy="400110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MF N210A </a:t>
              </a:r>
            </a:p>
            <a:p>
              <a:pPr algn="ctr"/>
              <a:r>
                <a:rPr lang="en-US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endPara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5210307" y="2129766"/>
              <a:ext cx="545342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8.0%</a:t>
              </a:r>
              <a:endPara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2189758" y="3230287"/>
              <a:ext cx="545342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1.6%</a:t>
              </a:r>
              <a:endPara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2952916" y="4430384"/>
              <a:ext cx="545342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5.3%</a:t>
              </a:r>
              <a:endPara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6050878" y="4446280"/>
              <a:ext cx="545342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8.3%</a:t>
              </a:r>
              <a:endParaRPr lang="en-US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2689359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resentation1" id="{F2D262DE-800F-458D-B359-9DBDE8078B12}" vid="{AA320954-F48D-4951-804C-F493EE461299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326</TotalTime>
  <Words>393</Words>
  <Application>Microsoft Macintosh PowerPoint</Application>
  <PresentationFormat>A4 Paper (210x297 mm)</PresentationFormat>
  <Paragraphs>9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Helvetica</vt:lpstr>
      <vt:lpstr>Office Theme</vt:lpstr>
      <vt:lpstr>PowerPoint Presentation</vt:lpstr>
      <vt:lpstr>PowerPoint Presentation</vt:lpstr>
      <vt:lpstr>PowerPoint Presentation</vt:lpstr>
    </vt:vector>
  </TitlesOfParts>
  <Manager/>
  <Company/>
  <LinksUpToDate>false</LinksUpToDate>
  <SharedDoc>false</SharedDoc>
  <HyperlinkBase/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Microsoft Office User</cp:lastModifiedBy>
  <cp:revision>1</cp:revision>
  <dcterms:modified xsi:type="dcterms:W3CDTF">2019-06-19T10:08:36Z</dcterms:modified>
</cp:coreProperties>
</file>